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5" r:id="rId2"/>
  </p:sldIdLst>
  <p:sldSz cx="9144000" cy="6858000" type="screen4x3"/>
  <p:notesSz cx="6792913" cy="992505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北村峰昭" initials="北村峰昭" lastIdx="1" clrIdx="0">
    <p:extLst>
      <p:ext uri="{19B8F6BF-5375-455C-9EA6-DF929625EA0E}">
        <p15:presenceInfo xmlns:p15="http://schemas.microsoft.com/office/powerpoint/2012/main" userId="b9aa565d2bbd3251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000" autoAdjust="0"/>
    <p:restoredTop sz="96429" autoAdjust="0"/>
  </p:normalViewPr>
  <p:slideViewPr>
    <p:cSldViewPr snapToGrid="0">
      <p:cViewPr varScale="1">
        <p:scale>
          <a:sx n="60" d="100"/>
          <a:sy n="60" d="100"/>
        </p:scale>
        <p:origin x="66" y="3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322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48100" y="0"/>
            <a:ext cx="294322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805381-C0C1-4D78-9A27-F0C3FE716FE6}" type="datetimeFigureOut">
              <a:rPr kumimoji="1" lang="ja-JP" altLang="en-US" smtClean="0"/>
              <a:t>2021/8/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63638" y="1241425"/>
            <a:ext cx="4465637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4013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3225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48100" y="9428163"/>
            <a:ext cx="2943225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E768EED-D0B8-4CED-8889-6F5100710D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62550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A5C8-56A1-4709-80F2-0E047D0A2822}" type="datetimeFigureOut">
              <a:rPr kumimoji="1" lang="ja-JP" altLang="en-US" smtClean="0"/>
              <a:t>2021/8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A620B-259A-4CC6-B622-E0B0A9EEFC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78444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A5C8-56A1-4709-80F2-0E047D0A2822}" type="datetimeFigureOut">
              <a:rPr kumimoji="1" lang="ja-JP" altLang="en-US" smtClean="0"/>
              <a:t>2021/8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A620B-259A-4CC6-B622-E0B0A9EEFC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86992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A5C8-56A1-4709-80F2-0E047D0A2822}" type="datetimeFigureOut">
              <a:rPr kumimoji="1" lang="ja-JP" altLang="en-US" smtClean="0"/>
              <a:t>2021/8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A620B-259A-4CC6-B622-E0B0A9EEFC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34664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A5C8-56A1-4709-80F2-0E047D0A2822}" type="datetimeFigureOut">
              <a:rPr kumimoji="1" lang="ja-JP" altLang="en-US" smtClean="0"/>
              <a:t>2021/8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A620B-259A-4CC6-B622-E0B0A9EEFC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09445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A5C8-56A1-4709-80F2-0E047D0A2822}" type="datetimeFigureOut">
              <a:rPr kumimoji="1" lang="ja-JP" altLang="en-US" smtClean="0"/>
              <a:t>2021/8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A620B-259A-4CC6-B622-E0B0A9EEFC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09611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A5C8-56A1-4709-80F2-0E047D0A2822}" type="datetimeFigureOut">
              <a:rPr kumimoji="1" lang="ja-JP" altLang="en-US" smtClean="0"/>
              <a:t>2021/8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A620B-259A-4CC6-B622-E0B0A9EEFC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4237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A5C8-56A1-4709-80F2-0E047D0A2822}" type="datetimeFigureOut">
              <a:rPr kumimoji="1" lang="ja-JP" altLang="en-US" smtClean="0"/>
              <a:t>2021/8/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A620B-259A-4CC6-B622-E0B0A9EEFC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92957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A5C8-56A1-4709-80F2-0E047D0A2822}" type="datetimeFigureOut">
              <a:rPr kumimoji="1" lang="ja-JP" altLang="en-US" smtClean="0"/>
              <a:t>2021/8/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A620B-259A-4CC6-B622-E0B0A9EEFC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6250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A5C8-56A1-4709-80F2-0E047D0A2822}" type="datetimeFigureOut">
              <a:rPr kumimoji="1" lang="ja-JP" altLang="en-US" smtClean="0"/>
              <a:t>2021/8/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A620B-259A-4CC6-B622-E0B0A9EEFC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10240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A5C8-56A1-4709-80F2-0E047D0A2822}" type="datetimeFigureOut">
              <a:rPr kumimoji="1" lang="ja-JP" altLang="en-US" smtClean="0"/>
              <a:t>2021/8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A620B-259A-4CC6-B622-E0B0A9EEFC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10849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A5C8-56A1-4709-80F2-0E047D0A2822}" type="datetimeFigureOut">
              <a:rPr kumimoji="1" lang="ja-JP" altLang="en-US" smtClean="0"/>
              <a:t>2021/8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A620B-259A-4CC6-B622-E0B0A9EEFC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23770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4DA5C8-56A1-4709-80F2-0E047D0A2822}" type="datetimeFigureOut">
              <a:rPr kumimoji="1" lang="ja-JP" altLang="en-US" smtClean="0"/>
              <a:t>2021/8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2A620B-259A-4CC6-B622-E0B0A9EEFC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23598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A644EFF-B409-4D85-8797-E2E0EC256A76}"/>
              </a:ext>
            </a:extLst>
          </p:cNvPr>
          <p:cNvSpPr txBox="1"/>
          <p:nvPr/>
        </p:nvSpPr>
        <p:spPr>
          <a:xfrm>
            <a:off x="1664246" y="620635"/>
            <a:ext cx="5199374" cy="646331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During July 2011-June 2012, 402 patients received hemodialysis at Nagasaki Renal Center</a:t>
            </a: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52AAE46C-98AE-461E-9801-F02EEB01B816}"/>
              </a:ext>
            </a:extLst>
          </p:cNvPr>
          <p:cNvSpPr/>
          <p:nvPr/>
        </p:nvSpPr>
        <p:spPr>
          <a:xfrm>
            <a:off x="1664246" y="2725344"/>
            <a:ext cx="5545108" cy="646331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Data collected from 339 patients on their birth month</a:t>
            </a:r>
          </a:p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during July 2011-June 2012</a:t>
            </a: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32A99836-639D-4CBA-8265-A0D4C0D2836B}"/>
              </a:ext>
            </a:extLst>
          </p:cNvPr>
          <p:cNvSpPr/>
          <p:nvPr/>
        </p:nvSpPr>
        <p:spPr>
          <a:xfrm>
            <a:off x="4827472" y="1467892"/>
            <a:ext cx="3417997" cy="954107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Excluded</a:t>
            </a:r>
          </a:p>
          <a:p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・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eath or leaving our facility before their birth month (n=30) </a:t>
            </a:r>
          </a:p>
          <a:p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・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oving in after their birth month (n=33)</a:t>
            </a:r>
          </a:p>
        </p:txBody>
      </p:sp>
      <p:cxnSp>
        <p:nvCxnSpPr>
          <p:cNvPr id="12" name="直線矢印コネクタ 11">
            <a:extLst>
              <a:ext uri="{FF2B5EF4-FFF2-40B4-BE49-F238E27FC236}">
                <a16:creationId xmlns:a16="http://schemas.microsoft.com/office/drawing/2014/main" id="{2958A3BD-43F9-4D59-9A2C-34C33C7F3C1D}"/>
              </a:ext>
            </a:extLst>
          </p:cNvPr>
          <p:cNvCxnSpPr/>
          <p:nvPr/>
        </p:nvCxnSpPr>
        <p:spPr>
          <a:xfrm flipH="1">
            <a:off x="3776624" y="1298912"/>
            <a:ext cx="1264" cy="1260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直線矢印コネクタ 13">
            <a:extLst>
              <a:ext uri="{FF2B5EF4-FFF2-40B4-BE49-F238E27FC236}">
                <a16:creationId xmlns:a16="http://schemas.microsoft.com/office/drawing/2014/main" id="{738198F4-3A10-4186-AE4E-D3F3B17EE0B3}"/>
              </a:ext>
            </a:extLst>
          </p:cNvPr>
          <p:cNvCxnSpPr>
            <a:cxnSpLocks/>
          </p:cNvCxnSpPr>
          <p:nvPr/>
        </p:nvCxnSpPr>
        <p:spPr>
          <a:xfrm>
            <a:off x="3777888" y="1974522"/>
            <a:ext cx="80038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AA5167E4-8A95-4885-A138-A1074ED0AEC6}"/>
              </a:ext>
            </a:extLst>
          </p:cNvPr>
          <p:cNvSpPr txBox="1"/>
          <p:nvPr/>
        </p:nvSpPr>
        <p:spPr>
          <a:xfrm>
            <a:off x="6928833" y="6518099"/>
            <a:ext cx="22151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igure</a:t>
            </a:r>
            <a:r>
              <a: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52AAE46C-98AE-461E-9801-F02EEB01B816}"/>
              </a:ext>
            </a:extLst>
          </p:cNvPr>
          <p:cNvSpPr/>
          <p:nvPr/>
        </p:nvSpPr>
        <p:spPr>
          <a:xfrm>
            <a:off x="1664246" y="4733808"/>
            <a:ext cx="5040675" cy="92333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During July 2012-June 2013, 286 patients</a:t>
            </a:r>
          </a:p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were included in this study, and their data were</a:t>
            </a:r>
          </a:p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collected on their birth month</a:t>
            </a:r>
          </a:p>
        </p:txBody>
      </p: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32A99836-639D-4CBA-8265-A0D4C0D2836B}"/>
              </a:ext>
            </a:extLst>
          </p:cNvPr>
          <p:cNvSpPr/>
          <p:nvPr/>
        </p:nvSpPr>
        <p:spPr>
          <a:xfrm>
            <a:off x="4827472" y="3675388"/>
            <a:ext cx="3417997" cy="73866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Excluded</a:t>
            </a:r>
          </a:p>
          <a:p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・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T data was not available (n=7)</a:t>
            </a:r>
          </a:p>
          <a:p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・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death or leaving our facility (n=46)</a:t>
            </a:r>
          </a:p>
        </p:txBody>
      </p:sp>
      <p:cxnSp>
        <p:nvCxnSpPr>
          <p:cNvPr id="26" name="直線矢印コネクタ 25">
            <a:extLst>
              <a:ext uri="{FF2B5EF4-FFF2-40B4-BE49-F238E27FC236}">
                <a16:creationId xmlns:a16="http://schemas.microsoft.com/office/drawing/2014/main" id="{2958A3BD-43F9-4D59-9A2C-34C33C7F3C1D}"/>
              </a:ext>
            </a:extLst>
          </p:cNvPr>
          <p:cNvCxnSpPr/>
          <p:nvPr/>
        </p:nvCxnSpPr>
        <p:spPr>
          <a:xfrm flipH="1">
            <a:off x="3776624" y="3421439"/>
            <a:ext cx="1264" cy="1260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直線矢印コネクタ 26">
            <a:extLst>
              <a:ext uri="{FF2B5EF4-FFF2-40B4-BE49-F238E27FC236}">
                <a16:creationId xmlns:a16="http://schemas.microsoft.com/office/drawing/2014/main" id="{738198F4-3A10-4186-AE4E-D3F3B17EE0B3}"/>
              </a:ext>
            </a:extLst>
          </p:cNvPr>
          <p:cNvCxnSpPr>
            <a:cxnSpLocks/>
          </p:cNvCxnSpPr>
          <p:nvPr/>
        </p:nvCxnSpPr>
        <p:spPr>
          <a:xfrm>
            <a:off x="3777888" y="4071863"/>
            <a:ext cx="80038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E3E2A2A3-69B1-46F0-BA70-4B845DC7B597}"/>
              </a:ext>
            </a:extLst>
          </p:cNvPr>
          <p:cNvSpPr txBox="1"/>
          <p:nvPr/>
        </p:nvSpPr>
        <p:spPr>
          <a:xfrm>
            <a:off x="639417" y="90794"/>
            <a:ext cx="7865165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800" dirty="0">
                <a:latin typeface="Arial" panose="020B0604020202020204" pitchFamily="34" charset="0"/>
                <a:cs typeface="Arial" panose="020B0604020202020204" pitchFamily="34" charset="0"/>
              </a:rPr>
              <a:t>Patient flow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78880A32-B8BC-47CB-B79D-630AD7FFB43E}"/>
              </a:ext>
            </a:extLst>
          </p:cNvPr>
          <p:cNvSpPr txBox="1"/>
          <p:nvPr/>
        </p:nvSpPr>
        <p:spPr>
          <a:xfrm>
            <a:off x="639416" y="6139155"/>
            <a:ext cx="786516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atients whose data could be collected in a couple of their birth months during July 2011- June 2013 were included in this study.</a:t>
            </a:r>
          </a:p>
        </p:txBody>
      </p:sp>
    </p:spTree>
    <p:extLst>
      <p:ext uri="{BB962C8B-B14F-4D97-AF65-F5344CB8AC3E}">
        <p14:creationId xmlns:p14="http://schemas.microsoft.com/office/powerpoint/2010/main" val="27053224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0</TotalTime>
  <Words>131</Words>
  <Application>Microsoft Office PowerPoint</Application>
  <PresentationFormat>画面に合わせる (4:3)</PresentationFormat>
  <Paragraphs>1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北村峰昭</dc:creator>
  <cp:lastModifiedBy>北村 峰昭</cp:lastModifiedBy>
  <cp:revision>29</cp:revision>
  <dcterms:created xsi:type="dcterms:W3CDTF">2021-07-04T00:25:33Z</dcterms:created>
  <dcterms:modified xsi:type="dcterms:W3CDTF">2021-08-04T07:53:32Z</dcterms:modified>
</cp:coreProperties>
</file>